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04" r:id="rId2"/>
    <p:sldId id="305" r:id="rId3"/>
    <p:sldId id="306" r:id="rId4"/>
  </p:sldIdLst>
  <p:sldSz cx="10801350" cy="13681075"/>
  <p:notesSz cx="6858000" cy="9144000"/>
  <p:defaultTextStyle>
    <a:defPPr>
      <a:defRPr lang="zh-CN"/>
    </a:defPPr>
    <a:lvl1pPr marL="0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699470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398941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098411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797881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497351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196822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4896292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595762" algn="l" defTabSz="1398941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309">
          <p15:clr>
            <a:srgbClr val="A4A3A4"/>
          </p15:clr>
        </p15:guide>
        <p15:guide id="2" pos="34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21" autoAdjust="0"/>
    <p:restoredTop sz="67251" autoAdjust="0"/>
  </p:normalViewPr>
  <p:slideViewPr>
    <p:cSldViewPr>
      <p:cViewPr>
        <p:scale>
          <a:sx n="60" d="100"/>
          <a:sy n="60" d="100"/>
        </p:scale>
        <p:origin x="-3270" y="-72"/>
      </p:cViewPr>
      <p:guideLst>
        <p:guide orient="horz" pos="4309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37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ng Ke" userId="586f04bf9585b8c9" providerId="LiveId" clId="{FF386248-63EB-4A95-A204-CAB060BD29B4}"/>
    <pc:docChg chg="addSld delSld modSld sldOrd">
      <pc:chgData name="Peng Ke" userId="586f04bf9585b8c9" providerId="LiveId" clId="{FF386248-63EB-4A95-A204-CAB060BD29B4}" dt="2021-01-12T14:21:41.420" v="404"/>
      <pc:docMkLst>
        <pc:docMk/>
      </pc:docMkLst>
      <pc:sldChg chg="modSp mod">
        <pc:chgData name="Peng Ke" userId="586f04bf9585b8c9" providerId="LiveId" clId="{FF386248-63EB-4A95-A204-CAB060BD29B4}" dt="2021-01-12T14:20:20.180" v="383" actId="404"/>
        <pc:sldMkLst>
          <pc:docMk/>
          <pc:sldMk cId="757828626" sldId="268"/>
        </pc:sldMkLst>
        <pc:spChg chg="mod">
          <ac:chgData name="Peng Ke" userId="586f04bf9585b8c9" providerId="LiveId" clId="{FF386248-63EB-4A95-A204-CAB060BD29B4}" dt="2021-01-12T14:20:20.180" v="383" actId="404"/>
          <ac:spMkLst>
            <pc:docMk/>
            <pc:sldMk cId="757828626" sldId="268"/>
            <ac:spMk id="3" creationId="{00000000-0000-0000-0000-000000000000}"/>
          </ac:spMkLst>
        </pc:spChg>
      </pc:sldChg>
      <pc:sldChg chg="modSp mod">
        <pc:chgData name="Peng Ke" userId="586f04bf9585b8c9" providerId="LiveId" clId="{FF386248-63EB-4A95-A204-CAB060BD29B4}" dt="2021-01-12T14:20:26.438" v="384" actId="404"/>
        <pc:sldMkLst>
          <pc:docMk/>
          <pc:sldMk cId="4243705851" sldId="269"/>
        </pc:sldMkLst>
        <pc:spChg chg="mod">
          <ac:chgData name="Peng Ke" userId="586f04bf9585b8c9" providerId="LiveId" clId="{FF386248-63EB-4A95-A204-CAB060BD29B4}" dt="2021-01-12T14:20:26.438" v="384" actId="404"/>
          <ac:spMkLst>
            <pc:docMk/>
            <pc:sldMk cId="4243705851" sldId="269"/>
            <ac:spMk id="3" creationId="{00000000-0000-0000-0000-000000000000}"/>
          </ac:spMkLst>
        </pc:spChg>
      </pc:sldChg>
      <pc:sldChg chg="addSp delSp modSp mod ord">
        <pc:chgData name="Peng Ke" userId="586f04bf9585b8c9" providerId="LiveId" clId="{FF386248-63EB-4A95-A204-CAB060BD29B4}" dt="2021-01-12T14:19:56.630" v="380" actId="255"/>
        <pc:sldMkLst>
          <pc:docMk/>
          <pc:sldMk cId="4243705851" sldId="270"/>
        </pc:sldMkLst>
        <pc:spChg chg="mod">
          <ac:chgData name="Peng Ke" userId="586f04bf9585b8c9" providerId="LiveId" clId="{FF386248-63EB-4A95-A204-CAB060BD29B4}" dt="2021-01-12T14:19:56.630" v="380" actId="255"/>
          <ac:spMkLst>
            <pc:docMk/>
            <pc:sldMk cId="4243705851" sldId="270"/>
            <ac:spMk id="3" creationId="{00000000-0000-0000-0000-000000000000}"/>
          </ac:spMkLst>
        </pc:spChg>
        <pc:spChg chg="add mod">
          <ac:chgData name="Peng Ke" userId="586f04bf9585b8c9" providerId="LiveId" clId="{FF386248-63EB-4A95-A204-CAB060BD29B4}" dt="2021-01-12T14:14:16.673" v="195" actId="1038"/>
          <ac:spMkLst>
            <pc:docMk/>
            <pc:sldMk cId="4243705851" sldId="270"/>
            <ac:spMk id="7" creationId="{FBA323C6-6B7E-48E5-9854-00F22CE5DFD3}"/>
          </ac:spMkLst>
        </pc:spChg>
        <pc:picChg chg="del">
          <ac:chgData name="Peng Ke" userId="586f04bf9585b8c9" providerId="LiveId" clId="{FF386248-63EB-4A95-A204-CAB060BD29B4}" dt="2021-01-12T14:14:00.921" v="110" actId="478"/>
          <ac:picMkLst>
            <pc:docMk/>
            <pc:sldMk cId="4243705851" sldId="270"/>
            <ac:picMk id="3074" creationId="{00000000-0000-0000-0000-000000000000}"/>
          </ac:picMkLst>
        </pc:picChg>
      </pc:sldChg>
      <pc:sldChg chg="modSp mod ord">
        <pc:chgData name="Peng Ke" userId="586f04bf9585b8c9" providerId="LiveId" clId="{FF386248-63EB-4A95-A204-CAB060BD29B4}" dt="2021-01-12T14:20:03.236" v="381" actId="255"/>
        <pc:sldMkLst>
          <pc:docMk/>
          <pc:sldMk cId="4243705851" sldId="271"/>
        </pc:sldMkLst>
        <pc:spChg chg="mod">
          <ac:chgData name="Peng Ke" userId="586f04bf9585b8c9" providerId="LiveId" clId="{FF386248-63EB-4A95-A204-CAB060BD29B4}" dt="2021-01-12T14:20:03.236" v="381" actId="255"/>
          <ac:spMkLst>
            <pc:docMk/>
            <pc:sldMk cId="4243705851" sldId="271"/>
            <ac:spMk id="3" creationId="{00000000-0000-0000-0000-000000000000}"/>
          </ac:spMkLst>
        </pc:spChg>
      </pc:sldChg>
      <pc:sldChg chg="modSp mod ord">
        <pc:chgData name="Peng Ke" userId="586f04bf9585b8c9" providerId="LiveId" clId="{FF386248-63EB-4A95-A204-CAB060BD29B4}" dt="2021-01-12T14:20:08.443" v="382" actId="404"/>
        <pc:sldMkLst>
          <pc:docMk/>
          <pc:sldMk cId="4243705851" sldId="272"/>
        </pc:sldMkLst>
        <pc:spChg chg="mod">
          <ac:chgData name="Peng Ke" userId="586f04bf9585b8c9" providerId="LiveId" clId="{FF386248-63EB-4A95-A204-CAB060BD29B4}" dt="2021-01-12T14:20:08.443" v="382" actId="404"/>
          <ac:spMkLst>
            <pc:docMk/>
            <pc:sldMk cId="4243705851" sldId="272"/>
            <ac:spMk id="3" creationId="{00000000-0000-0000-0000-000000000000}"/>
          </ac:spMkLst>
        </pc:spChg>
      </pc:sldChg>
      <pc:sldChg chg="modSp mod">
        <pc:chgData name="Peng Ke" userId="586f04bf9585b8c9" providerId="LiveId" clId="{FF386248-63EB-4A95-A204-CAB060BD29B4}" dt="2021-01-12T14:21:26.650" v="402"/>
        <pc:sldMkLst>
          <pc:docMk/>
          <pc:sldMk cId="4243705851" sldId="273"/>
        </pc:sldMkLst>
        <pc:spChg chg="mod">
          <ac:chgData name="Peng Ke" userId="586f04bf9585b8c9" providerId="LiveId" clId="{FF386248-63EB-4A95-A204-CAB060BD29B4}" dt="2021-01-12T14:21:26.650" v="402"/>
          <ac:spMkLst>
            <pc:docMk/>
            <pc:sldMk cId="4243705851" sldId="273"/>
            <ac:spMk id="3" creationId="{00000000-0000-0000-0000-000000000000}"/>
          </ac:spMkLst>
        </pc:spChg>
      </pc:sldChg>
      <pc:sldChg chg="del">
        <pc:chgData name="Peng Ke" userId="586f04bf9585b8c9" providerId="LiveId" clId="{FF386248-63EB-4A95-A204-CAB060BD29B4}" dt="2021-01-12T14:21:01.553" v="395" actId="47"/>
        <pc:sldMkLst>
          <pc:docMk/>
          <pc:sldMk cId="4243705851" sldId="275"/>
        </pc:sldMkLst>
      </pc:sldChg>
      <pc:sldChg chg="modSp mod">
        <pc:chgData name="Peng Ke" userId="586f04bf9585b8c9" providerId="LiveId" clId="{FF386248-63EB-4A95-A204-CAB060BD29B4}" dt="2021-01-12T14:21:41.420" v="404"/>
        <pc:sldMkLst>
          <pc:docMk/>
          <pc:sldMk cId="17326868" sldId="277"/>
        </pc:sldMkLst>
        <pc:spChg chg="mod">
          <ac:chgData name="Peng Ke" userId="586f04bf9585b8c9" providerId="LiveId" clId="{FF386248-63EB-4A95-A204-CAB060BD29B4}" dt="2021-01-12T14:21:41.420" v="404"/>
          <ac:spMkLst>
            <pc:docMk/>
            <pc:sldMk cId="17326868" sldId="277"/>
            <ac:spMk id="2" creationId="{00000000-0000-0000-0000-000000000000}"/>
          </ac:spMkLst>
        </pc:spChg>
      </pc:sldChg>
      <pc:sldChg chg="addSp modSp mod">
        <pc:chgData name="Peng Ke" userId="586f04bf9585b8c9" providerId="LiveId" clId="{FF386248-63EB-4A95-A204-CAB060BD29B4}" dt="2021-01-12T14:16:49.109" v="233"/>
        <pc:sldMkLst>
          <pc:docMk/>
          <pc:sldMk cId="1424133374" sldId="278"/>
        </pc:sldMkLst>
        <pc:spChg chg="mod">
          <ac:chgData name="Peng Ke" userId="586f04bf9585b8c9" providerId="LiveId" clId="{FF386248-63EB-4A95-A204-CAB060BD29B4}" dt="2021-01-12T14:16:49.109" v="233"/>
          <ac:spMkLst>
            <pc:docMk/>
            <pc:sldMk cId="1424133374" sldId="278"/>
            <ac:spMk id="2" creationId="{00000000-0000-0000-0000-000000000000}"/>
          </ac:spMkLst>
        </pc:spChg>
        <pc:spChg chg="add mod">
          <ac:chgData name="Peng Ke" userId="586f04bf9585b8c9" providerId="LiveId" clId="{FF386248-63EB-4A95-A204-CAB060BD29B4}" dt="2021-01-12T14:12:54.296" v="109"/>
          <ac:spMkLst>
            <pc:docMk/>
            <pc:sldMk cId="1424133374" sldId="278"/>
            <ac:spMk id="3" creationId="{5E4C63E4-9F4D-4FF5-A892-CA2A56E7EE21}"/>
          </ac:spMkLst>
        </pc:spChg>
      </pc:sldChg>
      <pc:sldChg chg="addSp modSp new mod">
        <pc:chgData name="Peng Ke" userId="586f04bf9585b8c9" providerId="LiveId" clId="{FF386248-63EB-4A95-A204-CAB060BD29B4}" dt="2021-01-12T14:17:38.350" v="264" actId="14100"/>
        <pc:sldMkLst>
          <pc:docMk/>
          <pc:sldMk cId="1637081418" sldId="279"/>
        </pc:sldMkLst>
        <pc:spChg chg="add mod">
          <ac:chgData name="Peng Ke" userId="586f04bf9585b8c9" providerId="LiveId" clId="{FF386248-63EB-4A95-A204-CAB060BD29B4}" dt="2021-01-12T14:17:38.350" v="264" actId="14100"/>
          <ac:spMkLst>
            <pc:docMk/>
            <pc:sldMk cId="1637081418" sldId="279"/>
            <ac:spMk id="2" creationId="{4A2FB271-29C1-461B-94A0-75DCF4D4B935}"/>
          </ac:spMkLst>
        </pc:spChg>
        <pc:spChg chg="add mod">
          <ac:chgData name="Peng Ke" userId="586f04bf9585b8c9" providerId="LiveId" clId="{FF386248-63EB-4A95-A204-CAB060BD29B4}" dt="2021-01-12T14:16:32.295" v="226"/>
          <ac:spMkLst>
            <pc:docMk/>
            <pc:sldMk cId="1637081418" sldId="279"/>
            <ac:spMk id="3" creationId="{B5438B65-5154-46A3-B1F8-D9618EDFAD98}"/>
          </ac:spMkLst>
        </pc:spChg>
      </pc:sldChg>
      <pc:sldChg chg="addSp modSp new mod">
        <pc:chgData name="Peng Ke" userId="586f04bf9585b8c9" providerId="LiveId" clId="{FF386248-63EB-4A95-A204-CAB060BD29B4}" dt="2021-01-12T14:18:36.589" v="347" actId="1035"/>
        <pc:sldMkLst>
          <pc:docMk/>
          <pc:sldMk cId="768247909" sldId="280"/>
        </pc:sldMkLst>
        <pc:spChg chg="add mod">
          <ac:chgData name="Peng Ke" userId="586f04bf9585b8c9" providerId="LiveId" clId="{FF386248-63EB-4A95-A204-CAB060BD29B4}" dt="2021-01-12T14:18:36.589" v="347" actId="1035"/>
          <ac:spMkLst>
            <pc:docMk/>
            <pc:sldMk cId="768247909" sldId="280"/>
            <ac:spMk id="2" creationId="{1AE70019-B6FF-4E9A-830B-C4483F4981FB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2885C4-90D4-4AA4-82CA-A342641C4FDD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74863" y="685800"/>
            <a:ext cx="27082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526604-F156-497E-B6D4-BA29CDBA97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8043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101" y="4250001"/>
            <a:ext cx="9181148" cy="293256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20203" y="7752609"/>
            <a:ext cx="7560945" cy="34962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9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989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984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978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973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968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962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957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838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827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830979" y="547878"/>
            <a:ext cx="2430304" cy="1167325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40067" y="547878"/>
            <a:ext cx="7110889" cy="1167325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1220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256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53232" y="8791358"/>
            <a:ext cx="9181148" cy="2717214"/>
          </a:xfrm>
        </p:spPr>
        <p:txBody>
          <a:bodyPr anchor="t"/>
          <a:lstStyle>
            <a:lvl1pPr algn="l">
              <a:defRPr sz="61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53232" y="5798624"/>
            <a:ext cx="9181148" cy="2992734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69947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39894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9841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9788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973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9682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9629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9576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039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40068" y="3192252"/>
            <a:ext cx="4770596" cy="9028877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90686" y="3192252"/>
            <a:ext cx="4770596" cy="9028877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6116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68" y="3062408"/>
            <a:ext cx="4772472" cy="1276266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470" indent="0">
              <a:buNone/>
              <a:defRPr sz="3100" b="1"/>
            </a:lvl2pPr>
            <a:lvl3pPr marL="1398941" indent="0">
              <a:buNone/>
              <a:defRPr sz="2800" b="1"/>
            </a:lvl3pPr>
            <a:lvl4pPr marL="2098411" indent="0">
              <a:buNone/>
              <a:defRPr sz="2400" b="1"/>
            </a:lvl4pPr>
            <a:lvl5pPr marL="2797881" indent="0">
              <a:buNone/>
              <a:defRPr sz="2400" b="1"/>
            </a:lvl5pPr>
            <a:lvl6pPr marL="3497351" indent="0">
              <a:buNone/>
              <a:defRPr sz="2400" b="1"/>
            </a:lvl6pPr>
            <a:lvl7pPr marL="4196822" indent="0">
              <a:buNone/>
              <a:defRPr sz="2400" b="1"/>
            </a:lvl7pPr>
            <a:lvl8pPr marL="4896292" indent="0">
              <a:buNone/>
              <a:defRPr sz="2400" b="1"/>
            </a:lvl8pPr>
            <a:lvl9pPr marL="5595762" indent="0">
              <a:buNone/>
              <a:defRPr sz="24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0068" y="4338674"/>
            <a:ext cx="4772472" cy="7882454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486936" y="3062408"/>
            <a:ext cx="4774347" cy="1276266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470" indent="0">
              <a:buNone/>
              <a:defRPr sz="3100" b="1"/>
            </a:lvl2pPr>
            <a:lvl3pPr marL="1398941" indent="0">
              <a:buNone/>
              <a:defRPr sz="2800" b="1"/>
            </a:lvl3pPr>
            <a:lvl4pPr marL="2098411" indent="0">
              <a:buNone/>
              <a:defRPr sz="2400" b="1"/>
            </a:lvl4pPr>
            <a:lvl5pPr marL="2797881" indent="0">
              <a:buNone/>
              <a:defRPr sz="2400" b="1"/>
            </a:lvl5pPr>
            <a:lvl6pPr marL="3497351" indent="0">
              <a:buNone/>
              <a:defRPr sz="2400" b="1"/>
            </a:lvl6pPr>
            <a:lvl7pPr marL="4196822" indent="0">
              <a:buNone/>
              <a:defRPr sz="2400" b="1"/>
            </a:lvl7pPr>
            <a:lvl8pPr marL="4896292" indent="0">
              <a:buNone/>
              <a:defRPr sz="2400" b="1"/>
            </a:lvl8pPr>
            <a:lvl9pPr marL="5595762" indent="0">
              <a:buNone/>
              <a:defRPr sz="24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486936" y="4338674"/>
            <a:ext cx="4774347" cy="7882454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335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592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02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068" y="544710"/>
            <a:ext cx="3553570" cy="2318182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23028" y="544711"/>
            <a:ext cx="6038255" cy="11676418"/>
          </a:xfrm>
        </p:spPr>
        <p:txBody>
          <a:bodyPr/>
          <a:lstStyle>
            <a:lvl1pPr>
              <a:defRPr sz="4900"/>
            </a:lvl1pPr>
            <a:lvl2pPr>
              <a:defRPr sz="4300"/>
            </a:lvl2pPr>
            <a:lvl3pPr>
              <a:defRPr sz="37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40068" y="2862893"/>
            <a:ext cx="3553570" cy="9358236"/>
          </a:xfrm>
        </p:spPr>
        <p:txBody>
          <a:bodyPr/>
          <a:lstStyle>
            <a:lvl1pPr marL="0" indent="0">
              <a:buNone/>
              <a:defRPr sz="2100"/>
            </a:lvl1pPr>
            <a:lvl2pPr marL="699470" indent="0">
              <a:buNone/>
              <a:defRPr sz="1800"/>
            </a:lvl2pPr>
            <a:lvl3pPr marL="1398941" indent="0">
              <a:buNone/>
              <a:defRPr sz="1500"/>
            </a:lvl3pPr>
            <a:lvl4pPr marL="2098411" indent="0">
              <a:buNone/>
              <a:defRPr sz="1400"/>
            </a:lvl4pPr>
            <a:lvl5pPr marL="2797881" indent="0">
              <a:buNone/>
              <a:defRPr sz="1400"/>
            </a:lvl5pPr>
            <a:lvl6pPr marL="3497351" indent="0">
              <a:buNone/>
              <a:defRPr sz="1400"/>
            </a:lvl6pPr>
            <a:lvl7pPr marL="4196822" indent="0">
              <a:buNone/>
              <a:defRPr sz="1400"/>
            </a:lvl7pPr>
            <a:lvl8pPr marL="4896292" indent="0">
              <a:buNone/>
              <a:defRPr sz="1400"/>
            </a:lvl8pPr>
            <a:lvl9pPr marL="5595762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1532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117140" y="9576752"/>
            <a:ext cx="6480810" cy="113059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117140" y="1222429"/>
            <a:ext cx="6480810" cy="8208645"/>
          </a:xfrm>
        </p:spPr>
        <p:txBody>
          <a:bodyPr/>
          <a:lstStyle>
            <a:lvl1pPr marL="0" indent="0">
              <a:buNone/>
              <a:defRPr sz="4900"/>
            </a:lvl1pPr>
            <a:lvl2pPr marL="699470" indent="0">
              <a:buNone/>
              <a:defRPr sz="4300"/>
            </a:lvl2pPr>
            <a:lvl3pPr marL="1398941" indent="0">
              <a:buNone/>
              <a:defRPr sz="3700"/>
            </a:lvl3pPr>
            <a:lvl4pPr marL="2098411" indent="0">
              <a:buNone/>
              <a:defRPr sz="3100"/>
            </a:lvl4pPr>
            <a:lvl5pPr marL="2797881" indent="0">
              <a:buNone/>
              <a:defRPr sz="3100"/>
            </a:lvl5pPr>
            <a:lvl6pPr marL="3497351" indent="0">
              <a:buNone/>
              <a:defRPr sz="3100"/>
            </a:lvl6pPr>
            <a:lvl7pPr marL="4196822" indent="0">
              <a:buNone/>
              <a:defRPr sz="3100"/>
            </a:lvl7pPr>
            <a:lvl8pPr marL="4896292" indent="0">
              <a:buNone/>
              <a:defRPr sz="3100"/>
            </a:lvl8pPr>
            <a:lvl9pPr marL="5595762" indent="0">
              <a:buNone/>
              <a:defRPr sz="3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117140" y="10707342"/>
            <a:ext cx="6480810" cy="1605625"/>
          </a:xfrm>
        </p:spPr>
        <p:txBody>
          <a:bodyPr/>
          <a:lstStyle>
            <a:lvl1pPr marL="0" indent="0">
              <a:buNone/>
              <a:defRPr sz="2100"/>
            </a:lvl1pPr>
            <a:lvl2pPr marL="699470" indent="0">
              <a:buNone/>
              <a:defRPr sz="1800"/>
            </a:lvl2pPr>
            <a:lvl3pPr marL="1398941" indent="0">
              <a:buNone/>
              <a:defRPr sz="1500"/>
            </a:lvl3pPr>
            <a:lvl4pPr marL="2098411" indent="0">
              <a:buNone/>
              <a:defRPr sz="1400"/>
            </a:lvl4pPr>
            <a:lvl5pPr marL="2797881" indent="0">
              <a:buNone/>
              <a:defRPr sz="1400"/>
            </a:lvl5pPr>
            <a:lvl6pPr marL="3497351" indent="0">
              <a:buNone/>
              <a:defRPr sz="1400"/>
            </a:lvl6pPr>
            <a:lvl7pPr marL="4196822" indent="0">
              <a:buNone/>
              <a:defRPr sz="1400"/>
            </a:lvl7pPr>
            <a:lvl8pPr marL="4896292" indent="0">
              <a:buNone/>
              <a:defRPr sz="1400"/>
            </a:lvl8pPr>
            <a:lvl9pPr marL="5595762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796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40068" y="547877"/>
            <a:ext cx="9721215" cy="2280179"/>
          </a:xfrm>
          <a:prstGeom prst="rect">
            <a:avLst/>
          </a:prstGeom>
        </p:spPr>
        <p:txBody>
          <a:bodyPr vert="horz" lIns="139894" tIns="69947" rIns="139894" bIns="69947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68" y="3192252"/>
            <a:ext cx="9721215" cy="9028877"/>
          </a:xfrm>
          <a:prstGeom prst="rect">
            <a:avLst/>
          </a:prstGeom>
        </p:spPr>
        <p:txBody>
          <a:bodyPr vert="horz" lIns="139894" tIns="69947" rIns="139894" bIns="69947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40067" y="12680330"/>
            <a:ext cx="2520315" cy="728391"/>
          </a:xfrm>
          <a:prstGeom prst="rect">
            <a:avLst/>
          </a:prstGeom>
        </p:spPr>
        <p:txBody>
          <a:bodyPr vert="horz" lIns="139894" tIns="69947" rIns="139894" bIns="69947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F1866-0FC5-42BD-875A-3E166FC855C1}" type="datetimeFigureOut">
              <a:rPr lang="zh-CN" altLang="en-US" smtClean="0"/>
              <a:t>2021/7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690461" y="12680330"/>
            <a:ext cx="3420428" cy="728391"/>
          </a:xfrm>
          <a:prstGeom prst="rect">
            <a:avLst/>
          </a:prstGeom>
        </p:spPr>
        <p:txBody>
          <a:bodyPr vert="horz" lIns="139894" tIns="69947" rIns="139894" bIns="69947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740968" y="12680330"/>
            <a:ext cx="2520315" cy="728391"/>
          </a:xfrm>
          <a:prstGeom prst="rect">
            <a:avLst/>
          </a:prstGeom>
        </p:spPr>
        <p:txBody>
          <a:bodyPr vert="horz" lIns="139894" tIns="69947" rIns="139894" bIns="69947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1E36C-D810-41F7-92B2-239807B063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812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98941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4603" indent="-524603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136639" indent="-437169" algn="l" defTabSz="1398941" rtl="0" eaLnBrk="1" latinLnBrk="0" hangingPunct="1">
        <a:spcBef>
          <a:spcPct val="20000"/>
        </a:spcBef>
        <a:buFont typeface="Arial" panose="020B0604020202020204" pitchFamily="34" charset="0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48676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448146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7616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847087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546557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246027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5945497" indent="-349735" algn="l" defTabSz="1398941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99470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398941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098411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797881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497351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96822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96292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95762" algn="l" defTabSz="1398941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" t="426" r="410" b="-683"/>
          <a:stretch/>
        </p:blipFill>
        <p:spPr>
          <a:xfrm>
            <a:off x="723495" y="7027645"/>
            <a:ext cx="9298945" cy="4248472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5381488" y="7032999"/>
            <a:ext cx="4640951" cy="21188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5372967" y="9836871"/>
            <a:ext cx="978347" cy="13681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9738241" y="7180259"/>
            <a:ext cx="1035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9801580" y="7978373"/>
            <a:ext cx="7856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9761409" y="8685578"/>
            <a:ext cx="866240" cy="215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/>
          <p:cNvCxnSpPr/>
          <p:nvPr/>
        </p:nvCxnSpPr>
        <p:spPr>
          <a:xfrm>
            <a:off x="5381488" y="6664120"/>
            <a:ext cx="458830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7162845" y="6429253"/>
            <a:ext cx="10375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plicate 2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363701" y="10731581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5381217" y="10088986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图片 52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69" t="34183" r="30348" b="50065"/>
          <a:stretch/>
        </p:blipFill>
        <p:spPr>
          <a:xfrm>
            <a:off x="5616585" y="4815422"/>
            <a:ext cx="1095490" cy="81707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365" t="33691" r="20052" b="50557"/>
          <a:stretch/>
        </p:blipFill>
        <p:spPr>
          <a:xfrm>
            <a:off x="4452853" y="4815424"/>
            <a:ext cx="1095490" cy="81707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69" t="17481" r="30348" b="66769"/>
          <a:stretch/>
        </p:blipFill>
        <p:spPr>
          <a:xfrm>
            <a:off x="5616585" y="3966027"/>
            <a:ext cx="1095490" cy="816966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69" t="535" r="30348" b="83713"/>
          <a:stretch/>
        </p:blipFill>
        <p:spPr>
          <a:xfrm>
            <a:off x="5616585" y="3104492"/>
            <a:ext cx="1095490" cy="81707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92" t="33596" r="10426" b="50652"/>
          <a:stretch/>
        </p:blipFill>
        <p:spPr>
          <a:xfrm>
            <a:off x="3293345" y="4815425"/>
            <a:ext cx="1095376" cy="817070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09" t="1000" r="20408" b="83248"/>
          <a:stretch/>
        </p:blipFill>
        <p:spPr>
          <a:xfrm>
            <a:off x="4452853" y="3104492"/>
            <a:ext cx="1095490" cy="817070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09" t="17753" r="20408" b="66497"/>
          <a:stretch/>
        </p:blipFill>
        <p:spPr>
          <a:xfrm>
            <a:off x="4452853" y="3966027"/>
            <a:ext cx="1095490" cy="816966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91" t="873" r="10426" b="83375"/>
          <a:stretch/>
        </p:blipFill>
        <p:spPr>
          <a:xfrm>
            <a:off x="3293231" y="3104492"/>
            <a:ext cx="1095490" cy="817070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xmlns="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91" t="17721" r="10423" b="66529"/>
          <a:stretch/>
        </p:blipFill>
        <p:spPr>
          <a:xfrm>
            <a:off x="3292888" y="3966027"/>
            <a:ext cx="1095833" cy="816966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 rot="16200000">
            <a:off x="1286195" y="3386680"/>
            <a:ext cx="136309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r>
              <a:rPr lang="en-US" altLang="zh-CN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63" name="TextBox 62"/>
          <p:cNvSpPr txBox="1"/>
          <p:nvPr/>
        </p:nvSpPr>
        <p:spPr>
          <a:xfrm rot="16200000">
            <a:off x="1342309" y="4366468"/>
            <a:ext cx="10892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10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xmlns="" id="{78E9D133-EB33-4D2E-9D72-2103EB9A367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23" t="83803" r="40094" b="445"/>
          <a:stretch/>
        </p:blipFill>
        <p:spPr>
          <a:xfrm>
            <a:off x="8557663" y="4815422"/>
            <a:ext cx="1095490" cy="817070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xmlns="" id="{3F074EEC-A6DC-4316-A01F-895AE315E8C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87" t="66658" r="50230" b="17502"/>
          <a:stretch/>
        </p:blipFill>
        <p:spPr>
          <a:xfrm>
            <a:off x="8557663" y="3963693"/>
            <a:ext cx="1095490" cy="821635"/>
          </a:xfrm>
          <a:prstGeom prst="rect">
            <a:avLst/>
          </a:prstGeom>
        </p:spPr>
      </p:pic>
      <p:sp>
        <p:nvSpPr>
          <p:cNvPr id="66" name="TextBox 65"/>
          <p:cNvSpPr txBox="1"/>
          <p:nvPr/>
        </p:nvSpPr>
        <p:spPr>
          <a:xfrm rot="16200000">
            <a:off x="7969548" y="4382041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1728267" y="2592065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uh7</a:t>
            </a:r>
          </a:p>
        </p:txBody>
      </p:sp>
      <p:pic>
        <p:nvPicPr>
          <p:cNvPr id="68" name="图片 67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05" t="17773" r="412" b="66477"/>
          <a:stretch/>
        </p:blipFill>
        <p:spPr>
          <a:xfrm>
            <a:off x="2159106" y="3966027"/>
            <a:ext cx="1095490" cy="816966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05" t="34183" r="412" b="50065"/>
          <a:stretch/>
        </p:blipFill>
        <p:spPr>
          <a:xfrm>
            <a:off x="2159108" y="4822075"/>
            <a:ext cx="1095490" cy="817070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05" t="1000" r="412" b="83248"/>
          <a:stretch/>
        </p:blipFill>
        <p:spPr>
          <a:xfrm>
            <a:off x="2159106" y="3104492"/>
            <a:ext cx="1095490" cy="817070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144091" y="31715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. 2B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72" name="图片 71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55" t="350" r="40171" b="83898"/>
          <a:stretch/>
        </p:blipFill>
        <p:spPr>
          <a:xfrm>
            <a:off x="6768755" y="3104492"/>
            <a:ext cx="1094522" cy="81707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76" t="16948" r="40240" b="67212"/>
          <a:stretch/>
        </p:blipFill>
        <p:spPr>
          <a:xfrm>
            <a:off x="6767672" y="3963694"/>
            <a:ext cx="1095605" cy="821635"/>
          </a:xfrm>
          <a:prstGeom prst="rect">
            <a:avLst/>
          </a:prstGeom>
        </p:spPr>
      </p:pic>
      <p:pic>
        <p:nvPicPr>
          <p:cNvPr id="74" name="图片 73">
            <a:extLst>
              <a:ext uri="{FF2B5EF4-FFF2-40B4-BE49-F238E27FC236}">
                <a16:creationId xmlns="" xmlns:a16="http://schemas.microsoft.com/office/drawing/2014/main" id="{B68C79C8-1BB8-48C2-A134-ED2BAB13008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84" t="33881" r="40242" b="50367"/>
          <a:stretch/>
        </p:blipFill>
        <p:spPr>
          <a:xfrm>
            <a:off x="6768755" y="4815422"/>
            <a:ext cx="1094522" cy="817070"/>
          </a:xfrm>
          <a:prstGeom prst="rect">
            <a:avLst/>
          </a:prstGeom>
        </p:spPr>
      </p:pic>
      <p:sp>
        <p:nvSpPr>
          <p:cNvPr id="75" name="直角三角形 74"/>
          <p:cNvSpPr/>
          <p:nvPr/>
        </p:nvSpPr>
        <p:spPr>
          <a:xfrm flipH="1">
            <a:off x="2253091" y="2911240"/>
            <a:ext cx="558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1339277" y="5104594"/>
            <a:ext cx="10951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10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7969433" y="5105991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0" name="直角三角形 79"/>
          <p:cNvSpPr/>
          <p:nvPr/>
        </p:nvSpPr>
        <p:spPr>
          <a:xfrm>
            <a:off x="5431277" y="6793485"/>
            <a:ext cx="450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9093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4" t="-282" r="278" b="-704"/>
          <a:stretch/>
        </p:blipFill>
        <p:spPr>
          <a:xfrm>
            <a:off x="511620" y="5792966"/>
            <a:ext cx="9300116" cy="4260428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 rot="16200000">
            <a:off x="-132355" y="6742360"/>
            <a:ext cx="1035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69016" y="7529841"/>
            <a:ext cx="7856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109187" y="6031013"/>
            <a:ext cx="866240" cy="215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545064" y="5801776"/>
            <a:ext cx="4616614" cy="21188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6110122" y="5792965"/>
            <a:ext cx="965787" cy="14076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TextBox 39"/>
          <p:cNvSpPr txBox="1"/>
          <p:nvPr/>
        </p:nvSpPr>
        <p:spPr>
          <a:xfrm>
            <a:off x="6110122" y="6768529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088186" y="5980378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直角三角形 41"/>
          <p:cNvSpPr/>
          <p:nvPr/>
        </p:nvSpPr>
        <p:spPr>
          <a:xfrm>
            <a:off x="593593" y="5548601"/>
            <a:ext cx="450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" t="16719" r="90143" b="67529"/>
          <a:stretch/>
        </p:blipFill>
        <p:spPr>
          <a:xfrm>
            <a:off x="5264962" y="1799977"/>
            <a:ext cx="1095605" cy="81707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xmlns="" id="{E418A5B9-8A5B-4AF4-8842-0558CAA261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" t="658" r="90327" b="83686"/>
          <a:stretch/>
        </p:blipFill>
        <p:spPr>
          <a:xfrm>
            <a:off x="5264962" y="3531981"/>
            <a:ext cx="1095605" cy="812090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1376759" y="1295911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epG2</a:t>
            </a: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xmlns="" id="{E418A5B9-8A5B-4AF4-8842-0558CAA261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08" t="658" r="80109" b="83686"/>
          <a:stretch/>
        </p:blipFill>
        <p:spPr>
          <a:xfrm>
            <a:off x="4101345" y="3531981"/>
            <a:ext cx="1095490" cy="812090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xmlns="" id="{E418A5B9-8A5B-4AF4-8842-0558CAA261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13" t="658" r="70298" b="83686"/>
          <a:stretch/>
        </p:blipFill>
        <p:spPr>
          <a:xfrm>
            <a:off x="2952468" y="3531981"/>
            <a:ext cx="1084745" cy="812090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xmlns="" id="{E418A5B9-8A5B-4AF4-8842-0558CAA261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63" t="658" r="60254" b="83686"/>
          <a:stretch/>
        </p:blipFill>
        <p:spPr>
          <a:xfrm>
            <a:off x="1807600" y="3531981"/>
            <a:ext cx="1095490" cy="812090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" t="33339" r="90143" b="50909"/>
          <a:stretch/>
        </p:blipFill>
        <p:spPr>
          <a:xfrm>
            <a:off x="5264962" y="2668093"/>
            <a:ext cx="1095605" cy="81707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08" t="16719" r="60409" b="67529"/>
          <a:stretch/>
        </p:blipFill>
        <p:spPr>
          <a:xfrm>
            <a:off x="1807600" y="1799977"/>
            <a:ext cx="1095490" cy="81707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8" t="16719" r="70433" b="67529"/>
          <a:stretch/>
        </p:blipFill>
        <p:spPr>
          <a:xfrm>
            <a:off x="2952468" y="1799977"/>
            <a:ext cx="1084745" cy="81707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31" t="16719" r="80186" b="67529"/>
          <a:stretch/>
        </p:blipFill>
        <p:spPr>
          <a:xfrm>
            <a:off x="4101345" y="1799977"/>
            <a:ext cx="1095490" cy="817070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44" t="33339" r="60173" b="50909"/>
          <a:stretch/>
        </p:blipFill>
        <p:spPr>
          <a:xfrm>
            <a:off x="1807600" y="2668093"/>
            <a:ext cx="1095490" cy="81707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49" t="33339" r="80168" b="50909"/>
          <a:stretch/>
        </p:blipFill>
        <p:spPr>
          <a:xfrm>
            <a:off x="4101345" y="2668093"/>
            <a:ext cx="1095490" cy="81707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34" t="33339" r="70178" b="50909"/>
          <a:stretch/>
        </p:blipFill>
        <p:spPr>
          <a:xfrm>
            <a:off x="2952468" y="2668093"/>
            <a:ext cx="1084630" cy="817070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xmlns="" id="{4765220E-9C75-492D-BE0E-57BC06DA5C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298" t="17530" r="30119" b="66759"/>
          <a:stretch/>
        </p:blipFill>
        <p:spPr>
          <a:xfrm>
            <a:off x="8206155" y="3528170"/>
            <a:ext cx="1095490" cy="814943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 rot="16200000">
            <a:off x="7618040" y="2919612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9" name="TextBox 58"/>
          <p:cNvSpPr txBox="1"/>
          <p:nvPr/>
        </p:nvSpPr>
        <p:spPr>
          <a:xfrm rot="16200000">
            <a:off x="7618040" y="3787591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0" name="TextBox 59"/>
          <p:cNvSpPr txBox="1"/>
          <p:nvPr/>
        </p:nvSpPr>
        <p:spPr>
          <a:xfrm rot="16200000">
            <a:off x="942382" y="2095408"/>
            <a:ext cx="136309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61" name="TextBox 60"/>
          <p:cNvSpPr txBox="1"/>
          <p:nvPr/>
        </p:nvSpPr>
        <p:spPr>
          <a:xfrm rot="16200000">
            <a:off x="994648" y="3073641"/>
            <a:ext cx="1089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991731" y="3844780"/>
            <a:ext cx="10951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="" xmlns:a16="http://schemas.microsoft.com/office/drawing/2014/main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" t="17113" r="90132" b="67148"/>
          <a:stretch/>
        </p:blipFill>
        <p:spPr>
          <a:xfrm>
            <a:off x="6416163" y="1799977"/>
            <a:ext cx="1095606" cy="816374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="" xmlns:a16="http://schemas.microsoft.com/office/drawing/2014/main" id="{E418A5B9-8A5B-4AF4-8842-0558CAA2613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" t="769" r="90178" b="83594"/>
          <a:stretch/>
        </p:blipFill>
        <p:spPr>
          <a:xfrm>
            <a:off x="6416163" y="3531981"/>
            <a:ext cx="1095606" cy="811132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="" xmlns:a16="http://schemas.microsoft.com/office/drawing/2014/main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" t="33499" r="90208" b="50750"/>
          <a:stretch/>
        </p:blipFill>
        <p:spPr>
          <a:xfrm>
            <a:off x="6416163" y="2668093"/>
            <a:ext cx="1095606" cy="817070"/>
          </a:xfrm>
          <a:prstGeom prst="rect">
            <a:avLst/>
          </a:prstGeom>
        </p:spPr>
      </p:pic>
      <p:sp>
        <p:nvSpPr>
          <p:cNvPr id="67" name="直角三角形 66"/>
          <p:cNvSpPr/>
          <p:nvPr/>
        </p:nvSpPr>
        <p:spPr>
          <a:xfrm flipH="1">
            <a:off x="1901583" y="1598133"/>
            <a:ext cx="558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xmlns="" id="{9EA76827-104F-4526-B3C8-65D3140D22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53" t="563" r="30464" b="83725"/>
          <a:stretch/>
        </p:blipFill>
        <p:spPr>
          <a:xfrm>
            <a:off x="8206155" y="2664073"/>
            <a:ext cx="1095490" cy="814995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144091" y="31715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. 2C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4539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77" t="33647" r="30039" b="50118"/>
          <a:stretch/>
        </p:blipFill>
        <p:spPr>
          <a:xfrm>
            <a:off x="5740822" y="3283179"/>
            <a:ext cx="1095605" cy="842123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72" t="33610" r="20245" b="50131"/>
          <a:stretch/>
        </p:blipFill>
        <p:spPr>
          <a:xfrm>
            <a:off x="4577205" y="3283179"/>
            <a:ext cx="1095490" cy="843368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70" t="33655" r="10446" b="50087"/>
          <a:stretch/>
        </p:blipFill>
        <p:spPr>
          <a:xfrm>
            <a:off x="3428328" y="3283179"/>
            <a:ext cx="1095605" cy="84331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81" t="16766" r="10335" b="66624"/>
          <a:stretch/>
        </p:blipFill>
        <p:spPr>
          <a:xfrm>
            <a:off x="3428328" y="2380190"/>
            <a:ext cx="1095605" cy="86157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81" t="394" r="10335" b="83794"/>
          <a:stretch/>
        </p:blipFill>
        <p:spPr>
          <a:xfrm>
            <a:off x="3428328" y="1521734"/>
            <a:ext cx="1095605" cy="82018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72" t="16651" r="20245" b="66738"/>
          <a:stretch/>
        </p:blipFill>
        <p:spPr>
          <a:xfrm>
            <a:off x="4577205" y="2380190"/>
            <a:ext cx="1095490" cy="86162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72" t="1236" r="20245" b="82954"/>
          <a:stretch/>
        </p:blipFill>
        <p:spPr>
          <a:xfrm>
            <a:off x="4577205" y="1521734"/>
            <a:ext cx="1095490" cy="82007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77" t="16658" r="30039" b="66732"/>
          <a:stretch/>
        </p:blipFill>
        <p:spPr>
          <a:xfrm>
            <a:off x="5740822" y="2380190"/>
            <a:ext cx="1095605" cy="86157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77" t="676" r="30039" b="83660"/>
          <a:stretch/>
        </p:blipFill>
        <p:spPr>
          <a:xfrm>
            <a:off x="5740822" y="1529411"/>
            <a:ext cx="1095605" cy="81250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1418242" y="1734113"/>
            <a:ext cx="136309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470508" y="2742658"/>
            <a:ext cx="1089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467591" y="3585635"/>
            <a:ext cx="10951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6A6EECAF-7A32-4AAF-95CB-557616AA463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39" t="83514" r="10278" b="213"/>
          <a:stretch/>
        </p:blipFill>
        <p:spPr>
          <a:xfrm>
            <a:off x="8682015" y="3281207"/>
            <a:ext cx="1095490" cy="84409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8B291CD6-866F-40B5-88E5-1C94AFCFBC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238" t="66555" r="10179" b="16680"/>
          <a:stretch/>
        </p:blipFill>
        <p:spPr>
          <a:xfrm>
            <a:off x="8682015" y="2372150"/>
            <a:ext cx="1095490" cy="86961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8093900" y="2657617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8093900" y="3507154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56" t="33676" r="383" b="50066"/>
          <a:stretch/>
        </p:blipFill>
        <p:spPr>
          <a:xfrm>
            <a:off x="2283461" y="3283179"/>
            <a:ext cx="1092975" cy="84331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18" t="16841" r="121" b="66547"/>
          <a:stretch/>
        </p:blipFill>
        <p:spPr>
          <a:xfrm>
            <a:off x="2283461" y="2380190"/>
            <a:ext cx="1092975" cy="86167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xmlns="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251" t="223" r="188" b="84114"/>
          <a:stretch/>
        </p:blipFill>
        <p:spPr>
          <a:xfrm>
            <a:off x="2283461" y="1521734"/>
            <a:ext cx="1092975" cy="81245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852619" y="1021031"/>
            <a:ext cx="1242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UVEC</a:t>
            </a:r>
          </a:p>
        </p:txBody>
      </p:sp>
      <p:sp>
        <p:nvSpPr>
          <p:cNvPr id="22" name="直角三角形 21"/>
          <p:cNvSpPr/>
          <p:nvPr/>
        </p:nvSpPr>
        <p:spPr>
          <a:xfrm flipH="1">
            <a:off x="2377443" y="1316639"/>
            <a:ext cx="558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3" name="图片 22">
            <a:extLst>
              <a:ext uri="{FF2B5EF4-FFF2-40B4-BE49-F238E27FC236}">
                <a16:creationId xmlns="" xmlns:a16="http://schemas.microsoft.com/office/drawing/2014/main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58" t="1307" r="40159" b="83029"/>
          <a:stretch/>
        </p:blipFill>
        <p:spPr>
          <a:xfrm>
            <a:off x="6892023" y="1529411"/>
            <a:ext cx="1095605" cy="812505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="" xmlns:a16="http://schemas.microsoft.com/office/drawing/2014/main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34" t="16904" r="40183" b="66486"/>
          <a:stretch/>
        </p:blipFill>
        <p:spPr>
          <a:xfrm>
            <a:off x="6892023" y="2380190"/>
            <a:ext cx="1095605" cy="861575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="" xmlns:a16="http://schemas.microsoft.com/office/drawing/2014/main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34" t="33831" r="40182" b="49934"/>
          <a:stretch/>
        </p:blipFill>
        <p:spPr>
          <a:xfrm>
            <a:off x="6892023" y="3283179"/>
            <a:ext cx="1095605" cy="842123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="" xmlns:a16="http://schemas.microsoft.com/office/drawing/2014/main" id="{0ECF9D78-172C-4459-A5FD-8D033246E0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4" r="-1" b="410"/>
          <a:stretch/>
        </p:blipFill>
        <p:spPr>
          <a:xfrm>
            <a:off x="831918" y="5904433"/>
            <a:ext cx="9217024" cy="4218256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 rot="16200000">
            <a:off x="9670857" y="6063668"/>
            <a:ext cx="11394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oginsenoside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t1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9746708" y="6861782"/>
            <a:ext cx="864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unical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9702508" y="7584889"/>
            <a:ext cx="952864" cy="215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osendanin</a:t>
            </a:r>
            <a:endParaRPr lang="en-US" altLang="zh-CN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直角三角形 29"/>
          <p:cNvSpPr/>
          <p:nvPr/>
        </p:nvSpPr>
        <p:spPr>
          <a:xfrm>
            <a:off x="5461481" y="5664572"/>
            <a:ext cx="4500000" cy="144000"/>
          </a:xfrm>
          <a:prstGeom prst="rt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5422558" y="5913244"/>
            <a:ext cx="4616614" cy="21188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8181968" y="8715078"/>
            <a:ext cx="965787" cy="14076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8182768" y="9685116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8160832" y="8896965"/>
            <a:ext cx="9988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1100" b="1" dirty="0" smtClean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44091" y="31715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. 2D</a:t>
            </a:r>
          </a:p>
        </p:txBody>
      </p:sp>
    </p:spTree>
    <p:extLst>
      <p:ext uri="{BB962C8B-B14F-4D97-AF65-F5344CB8AC3E}">
        <p14:creationId xmlns:p14="http://schemas.microsoft.com/office/powerpoint/2010/main" val="2020404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510</TotalTime>
  <Words>53</Words>
  <Application>Microsoft Office PowerPoint</Application>
  <PresentationFormat>自定义</PresentationFormat>
  <Paragraphs>40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​​</vt:lpstr>
      <vt:lpstr>PowerPoint 演示文稿</vt:lpstr>
      <vt:lpstr>PowerPoint 演示文稿</vt:lpstr>
      <vt:lpstr>PowerPoint 演示文稿</vt:lpstr>
    </vt:vector>
  </TitlesOfParts>
  <Company>whio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g Lab</dc:creator>
  <cp:lastModifiedBy>Li</cp:lastModifiedBy>
  <cp:revision>808</cp:revision>
  <dcterms:created xsi:type="dcterms:W3CDTF">2019-05-13T02:22:20Z</dcterms:created>
  <dcterms:modified xsi:type="dcterms:W3CDTF">2021-07-08T09:57:50Z</dcterms:modified>
</cp:coreProperties>
</file>